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85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4032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1" y="1600201"/>
            <a:ext cx="4758420" cy="66496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667025" y="838219"/>
            <a:ext cx="2590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</a:rPr>
              <a:t>Figure S5 </a:t>
            </a:r>
            <a:endParaRPr lang="en-US" sz="1600" dirty="0">
              <a:solidFill>
                <a:prstClr val="black"/>
              </a:solidFill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2851299" y="1578933"/>
            <a:ext cx="1187301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3023221" y="1314924"/>
            <a:ext cx="15683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168</a:t>
            </a:r>
            <a:endParaRPr 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>
            <a:off x="1895276" y="8241027"/>
            <a:ext cx="771749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886843" y="8227391"/>
            <a:ext cx="15683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168*</a:t>
            </a:r>
            <a:endParaRPr 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4890977" y="7272668"/>
            <a:ext cx="385874" cy="0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281125" y="3505200"/>
            <a:ext cx="2995726" cy="0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455583" y="3274831"/>
            <a:ext cx="18890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E insertion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6963" y="8686800"/>
            <a:ext cx="5943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5.</a:t>
            </a:r>
            <a:r>
              <a:rPr lang="en-US" sz="1200" dirty="0" smtClean="0"/>
              <a:t>  </a:t>
            </a:r>
            <a:r>
              <a:rPr lang="en-US" sz="1200" dirty="0"/>
              <a:t>Multiple sequence alignment of miR168 precursors from </a:t>
            </a:r>
            <a:r>
              <a:rPr lang="en-US" sz="1200" i="1" dirty="0" err="1"/>
              <a:t>Solanaceae</a:t>
            </a:r>
            <a:r>
              <a:rPr lang="en-US" sz="1200" dirty="0"/>
              <a:t> indicating site of MITE insertion.  miR168 and miR168* sequences have been marked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91806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8</TotalTime>
  <Words>32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8</cp:revision>
  <dcterms:created xsi:type="dcterms:W3CDTF">2006-08-16T00:00:00Z</dcterms:created>
  <dcterms:modified xsi:type="dcterms:W3CDTF">2014-08-25T07:04:06Z</dcterms:modified>
</cp:coreProperties>
</file>